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445570" y="248198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716_Brain 1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 flipV="1">
            <a:off x="2090309" y="1391478"/>
            <a:ext cx="354717" cy="29491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 flipH="1" flipV="1">
            <a:off x="1720357" y="1317056"/>
            <a:ext cx="238684" cy="34120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FCFA881-A629-F683-4635-5DA29BEFA0E1}"/>
              </a:ext>
            </a:extLst>
          </p:cNvPr>
          <p:cNvSpPr txBox="1"/>
          <p:nvPr/>
        </p:nvSpPr>
        <p:spPr>
          <a:xfrm>
            <a:off x="1720357" y="1729038"/>
            <a:ext cx="15701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: axon tuft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A9B867B-B4A2-E3A3-9264-BCF2F8011062}"/>
              </a:ext>
            </a:extLst>
          </p:cNvPr>
          <p:cNvSpPr txBox="1"/>
          <p:nvPr/>
        </p:nvSpPr>
        <p:spPr>
          <a:xfrm>
            <a:off x="5935016" y="1631599"/>
            <a:ext cx="752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9FB9BBA-5D5C-449C-9C37-AD29CB3A13AA}"/>
              </a:ext>
            </a:extLst>
          </p:cNvPr>
          <p:cNvCxnSpPr>
            <a:cxnSpLocks/>
          </p:cNvCxnSpPr>
          <p:nvPr/>
        </p:nvCxnSpPr>
        <p:spPr>
          <a:xfrm flipV="1">
            <a:off x="6171543" y="1345565"/>
            <a:ext cx="354717" cy="29491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02A1074-49B7-BAAA-838F-D7CF5A0C1D0C}"/>
              </a:ext>
            </a:extLst>
          </p:cNvPr>
          <p:cNvCxnSpPr>
            <a:cxnSpLocks/>
          </p:cNvCxnSpPr>
          <p:nvPr/>
        </p:nvCxnSpPr>
        <p:spPr>
          <a:xfrm flipH="1" flipV="1">
            <a:off x="5801591" y="1271143"/>
            <a:ext cx="238684" cy="34120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161AE478-C443-3672-C2CF-7AFDAD5E5A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404" y="501820"/>
            <a:ext cx="3516627" cy="1903738"/>
          </a:xfrm>
          <a:prstGeom prst="rect">
            <a:avLst/>
          </a:prstGeom>
        </p:spPr>
      </p:pic>
      <p:pic>
        <p:nvPicPr>
          <p:cNvPr id="7" name="Picture 6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D079BE37-9F14-5412-12CC-391858E323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8125" y="468535"/>
            <a:ext cx="3896095" cy="2069996"/>
          </a:xfrm>
          <a:prstGeom prst="rect">
            <a:avLst/>
          </a:prstGeom>
        </p:spPr>
      </p:pic>
      <p:pic>
        <p:nvPicPr>
          <p:cNvPr id="11" name="Picture 10" descr="A picture containing light, dark, blurry, ocean floor&#10;&#10;Description automatically generated">
            <a:extLst>
              <a:ext uri="{FF2B5EF4-FFF2-40B4-BE49-F238E27FC236}">
                <a16:creationId xmlns:a16="http://schemas.microsoft.com/office/drawing/2014/main" id="{BA7CEE29-6645-450D-2AC9-D57A137267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51314" y="428890"/>
            <a:ext cx="4121230" cy="2220086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6B2783FE-35C7-1CC9-2E0B-7F3B80F28813}"/>
              </a:ext>
            </a:extLst>
          </p:cNvPr>
          <p:cNvSpPr txBox="1"/>
          <p:nvPr/>
        </p:nvSpPr>
        <p:spPr>
          <a:xfrm>
            <a:off x="4168466" y="255962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755_Brain 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9EDA913-4DDD-8957-5627-C96816051F00}"/>
              </a:ext>
            </a:extLst>
          </p:cNvPr>
          <p:cNvSpPr txBox="1"/>
          <p:nvPr/>
        </p:nvSpPr>
        <p:spPr>
          <a:xfrm>
            <a:off x="8157553" y="255962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1755_Brain 2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D9C3FA17-9B0C-6315-25F5-41E81BCF3832}"/>
              </a:ext>
            </a:extLst>
          </p:cNvPr>
          <p:cNvCxnSpPr>
            <a:cxnSpLocks/>
          </p:cNvCxnSpPr>
          <p:nvPr/>
        </p:nvCxnSpPr>
        <p:spPr>
          <a:xfrm flipV="1">
            <a:off x="10339857" y="998429"/>
            <a:ext cx="373077" cy="35335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B23DF214-7296-257D-B97A-9BEB001174ED}"/>
              </a:ext>
            </a:extLst>
          </p:cNvPr>
          <p:cNvCxnSpPr>
            <a:cxnSpLocks/>
          </p:cNvCxnSpPr>
          <p:nvPr/>
        </p:nvCxnSpPr>
        <p:spPr>
          <a:xfrm flipV="1">
            <a:off x="6196730" y="1116308"/>
            <a:ext cx="373077" cy="35335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3C2A1D4B-E01C-27E1-1639-D863E30CC93E}"/>
              </a:ext>
            </a:extLst>
          </p:cNvPr>
          <p:cNvCxnSpPr>
            <a:cxnSpLocks/>
          </p:cNvCxnSpPr>
          <p:nvPr/>
        </p:nvCxnSpPr>
        <p:spPr>
          <a:xfrm flipH="1" flipV="1">
            <a:off x="995896" y="1020699"/>
            <a:ext cx="352228" cy="44896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7">
            <a:extLst>
              <a:ext uri="{FF2B5EF4-FFF2-40B4-BE49-F238E27FC236}">
                <a16:creationId xmlns:a16="http://schemas.microsoft.com/office/drawing/2014/main" id="{092CE940-6542-35BA-CD96-A42E91455D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96" y="3928098"/>
            <a:ext cx="3868060" cy="2271902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60C0B7BC-527D-5FC1-D35E-42536A99A42D}"/>
              </a:ext>
            </a:extLst>
          </p:cNvPr>
          <p:cNvSpPr txBox="1"/>
          <p:nvPr/>
        </p:nvSpPr>
        <p:spPr>
          <a:xfrm>
            <a:off x="164404" y="617151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04268_Brain 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81C9A14-6544-9B10-41AA-91838A27BF37}"/>
              </a:ext>
            </a:extLst>
          </p:cNvPr>
          <p:cNvSpPr txBox="1"/>
          <p:nvPr/>
        </p:nvSpPr>
        <p:spPr>
          <a:xfrm>
            <a:off x="4110414" y="620479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20844_Brain 1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2C32DE3-2FB1-9795-710D-B577FE4DDE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16455" y="3918726"/>
            <a:ext cx="3837122" cy="2290646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FC9E0488-B0A4-0D77-33CE-C0388A3DDE1C}"/>
              </a:ext>
            </a:extLst>
          </p:cNvPr>
          <p:cNvSpPr txBox="1"/>
          <p:nvPr/>
        </p:nvSpPr>
        <p:spPr>
          <a:xfrm>
            <a:off x="143609" y="127689"/>
            <a:ext cx="534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DAN-g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1D7CB79-EB8D-C26B-A0C9-BDCAD9DA9899}"/>
              </a:ext>
            </a:extLst>
          </p:cNvPr>
          <p:cNvSpPr txBox="1"/>
          <p:nvPr/>
        </p:nvSpPr>
        <p:spPr>
          <a:xfrm>
            <a:off x="146406" y="3525247"/>
            <a:ext cx="52886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OAN-g1</a:t>
            </a:r>
          </a:p>
        </p:txBody>
      </p:sp>
    </p:spTree>
    <p:extLst>
      <p:ext uri="{BB962C8B-B14F-4D97-AF65-F5344CB8AC3E}">
        <p14:creationId xmlns:p14="http://schemas.microsoft.com/office/powerpoint/2010/main" val="3829835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9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9</cp:revision>
  <dcterms:created xsi:type="dcterms:W3CDTF">2022-06-08T22:16:26Z</dcterms:created>
  <dcterms:modified xsi:type="dcterms:W3CDTF">2022-06-08T22:52:47Z</dcterms:modified>
</cp:coreProperties>
</file>